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397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852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906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2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451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534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9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463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990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792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589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46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F1A71-2C4F-4FD2-B176-A514EE1386BC}" type="datetimeFigureOut">
              <a:rPr lang="en-US" smtClean="0"/>
              <a:t>4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D6F18-2F97-4A6D-8C53-2EA5F2003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176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993794" y="38212"/>
            <a:ext cx="2736811" cy="3657601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649514" y="-30467"/>
            <a:ext cx="2736057" cy="3795713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344862" y="2904967"/>
            <a:ext cx="2568575" cy="3771900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-76200" y="1491871"/>
            <a:ext cx="685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E2</a:t>
            </a:r>
            <a:endParaRPr lang="en-US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609599" y="1666153"/>
            <a:ext cx="228601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141959" y="1362421"/>
            <a:ext cx="1309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MPRSS2</a:t>
            </a:r>
            <a:endParaRPr lang="en-US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181600" y="1579986"/>
            <a:ext cx="228601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828801" y="4725829"/>
            <a:ext cx="1066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actin</a:t>
            </a:r>
            <a:endParaRPr lang="en-US" dirty="0"/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2666999" y="4909164"/>
            <a:ext cx="228601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 rot="18724095">
            <a:off x="830139" y="456959"/>
            <a:ext cx="7424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Control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 rot="18724095">
            <a:off x="1094393" y="31034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 rot="18724095">
            <a:off x="1423231" y="31552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 rot="18724095">
            <a:off x="1721710" y="298150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 rot="18724095">
            <a:off x="2029281" y="314630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 rot="18724095">
            <a:off x="2333067" y="337492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 rot="18724095">
            <a:off x="2644072" y="332642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 rot="18724095">
            <a:off x="2930111" y="327671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 rot="18724095">
            <a:off x="3258949" y="33285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 rot="18724095">
            <a:off x="3578333" y="32800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 rot="18724095">
            <a:off x="5466479" y="380233"/>
            <a:ext cx="7424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Control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 rot="18724095">
            <a:off x="5730733" y="233618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34" name="TextBox 33"/>
          <p:cNvSpPr txBox="1"/>
          <p:nvPr/>
        </p:nvSpPr>
        <p:spPr>
          <a:xfrm rot="18724095">
            <a:off x="6059571" y="238800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35" name="TextBox 34"/>
          <p:cNvSpPr txBox="1"/>
          <p:nvPr/>
        </p:nvSpPr>
        <p:spPr>
          <a:xfrm rot="18724095">
            <a:off x="6358050" y="22142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36" name="TextBox 35"/>
          <p:cNvSpPr txBox="1"/>
          <p:nvPr/>
        </p:nvSpPr>
        <p:spPr>
          <a:xfrm rot="18724095">
            <a:off x="6665621" y="23790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37" name="TextBox 36"/>
          <p:cNvSpPr txBox="1"/>
          <p:nvPr/>
        </p:nvSpPr>
        <p:spPr>
          <a:xfrm rot="18724095">
            <a:off x="6969407" y="26076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 rot="18724095">
            <a:off x="7280412" y="25591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 rot="18724095">
            <a:off x="7566451" y="250945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 rot="18724095">
            <a:off x="7895289" y="256128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41" name="TextBox 40"/>
          <p:cNvSpPr txBox="1"/>
          <p:nvPr/>
        </p:nvSpPr>
        <p:spPr>
          <a:xfrm rot="18724095">
            <a:off x="8214673" y="292460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 rot="18724095">
            <a:off x="2996695" y="3768051"/>
            <a:ext cx="7424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Control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 rot="18724095">
            <a:off x="3260949" y="362143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 rot="18724095">
            <a:off x="3589787" y="3626618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 rot="18724095">
            <a:off x="3888266" y="3609242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 rot="18724095">
            <a:off x="4195837" y="3625722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 rot="18724095">
            <a:off x="4499623" y="364858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 rot="18724095">
            <a:off x="4810628" y="364373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 rot="18724095">
            <a:off x="5096667" y="3638763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50" name="TextBox 49"/>
          <p:cNvSpPr txBox="1"/>
          <p:nvPr/>
        </p:nvSpPr>
        <p:spPr>
          <a:xfrm rot="18724095">
            <a:off x="5425505" y="364394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51" name="TextBox 50"/>
          <p:cNvSpPr txBox="1"/>
          <p:nvPr/>
        </p:nvSpPr>
        <p:spPr>
          <a:xfrm rot="18724095">
            <a:off x="5744889" y="363909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cxnSp>
        <p:nvCxnSpPr>
          <p:cNvPr id="68" name="Straight Connector 67"/>
          <p:cNvCxnSpPr/>
          <p:nvPr/>
        </p:nvCxnSpPr>
        <p:spPr>
          <a:xfrm>
            <a:off x="3446023" y="262808"/>
            <a:ext cx="702058" cy="395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3407431" y="37391"/>
            <a:ext cx="816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urcumin</a:t>
            </a:r>
            <a:endParaRPr lang="en-US" sz="1200" dirty="0"/>
          </a:p>
        </p:txBody>
      </p:sp>
      <p:cxnSp>
        <p:nvCxnSpPr>
          <p:cNvPr id="71" name="Straight Connector 70"/>
          <p:cNvCxnSpPr/>
          <p:nvPr/>
        </p:nvCxnSpPr>
        <p:spPr>
          <a:xfrm>
            <a:off x="1531308" y="262808"/>
            <a:ext cx="74869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1516068" y="39479"/>
            <a:ext cx="763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Brazilin</a:t>
            </a:r>
            <a:endParaRPr lang="en-US" sz="1200" dirty="0"/>
          </a:p>
        </p:txBody>
      </p:sp>
      <p:cxnSp>
        <p:nvCxnSpPr>
          <p:cNvPr id="75" name="Straight Connector 74"/>
          <p:cNvCxnSpPr/>
          <p:nvPr/>
        </p:nvCxnSpPr>
        <p:spPr>
          <a:xfrm>
            <a:off x="2452597" y="266762"/>
            <a:ext cx="7998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2387253" y="43433"/>
            <a:ext cx="665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    TF-3</a:t>
            </a:r>
            <a:endParaRPr lang="en-US" sz="1200" dirty="0"/>
          </a:p>
        </p:txBody>
      </p:sp>
      <p:cxnSp>
        <p:nvCxnSpPr>
          <p:cNvPr id="86" name="Straight Connector 85"/>
          <p:cNvCxnSpPr/>
          <p:nvPr/>
        </p:nvCxnSpPr>
        <p:spPr>
          <a:xfrm>
            <a:off x="8083736" y="215180"/>
            <a:ext cx="702058" cy="395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8045144" y="-10237"/>
            <a:ext cx="816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urcumin</a:t>
            </a:r>
            <a:endParaRPr lang="en-US" sz="1200" dirty="0"/>
          </a:p>
        </p:txBody>
      </p:sp>
      <p:cxnSp>
        <p:nvCxnSpPr>
          <p:cNvPr id="88" name="Straight Connector 87"/>
          <p:cNvCxnSpPr/>
          <p:nvPr/>
        </p:nvCxnSpPr>
        <p:spPr>
          <a:xfrm>
            <a:off x="6169021" y="215180"/>
            <a:ext cx="74869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6153781" y="-8149"/>
            <a:ext cx="763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Brazilin</a:t>
            </a:r>
            <a:endParaRPr lang="en-US" sz="1200" dirty="0"/>
          </a:p>
        </p:txBody>
      </p:sp>
      <p:cxnSp>
        <p:nvCxnSpPr>
          <p:cNvPr id="90" name="Straight Connector 89"/>
          <p:cNvCxnSpPr/>
          <p:nvPr/>
        </p:nvCxnSpPr>
        <p:spPr>
          <a:xfrm>
            <a:off x="7090310" y="219134"/>
            <a:ext cx="7998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7024966" y="-4195"/>
            <a:ext cx="665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    TF-3</a:t>
            </a:r>
            <a:endParaRPr lang="en-US" sz="1200" dirty="0"/>
          </a:p>
        </p:txBody>
      </p:sp>
      <p:cxnSp>
        <p:nvCxnSpPr>
          <p:cNvPr id="92" name="Straight Connector 91"/>
          <p:cNvCxnSpPr/>
          <p:nvPr/>
        </p:nvCxnSpPr>
        <p:spPr>
          <a:xfrm>
            <a:off x="5675639" y="3593546"/>
            <a:ext cx="702058" cy="395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5637047" y="3368129"/>
            <a:ext cx="816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urcumin</a:t>
            </a:r>
            <a:endParaRPr lang="en-US" sz="1200" dirty="0"/>
          </a:p>
        </p:txBody>
      </p:sp>
      <p:cxnSp>
        <p:nvCxnSpPr>
          <p:cNvPr id="94" name="Straight Connector 93"/>
          <p:cNvCxnSpPr/>
          <p:nvPr/>
        </p:nvCxnSpPr>
        <p:spPr>
          <a:xfrm>
            <a:off x="3760924" y="3593546"/>
            <a:ext cx="74869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3745684" y="3370217"/>
            <a:ext cx="763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Brazilin</a:t>
            </a:r>
            <a:endParaRPr lang="en-US" sz="1200" dirty="0"/>
          </a:p>
        </p:txBody>
      </p:sp>
      <p:cxnSp>
        <p:nvCxnSpPr>
          <p:cNvPr id="96" name="Straight Connector 95"/>
          <p:cNvCxnSpPr/>
          <p:nvPr/>
        </p:nvCxnSpPr>
        <p:spPr>
          <a:xfrm>
            <a:off x="4682213" y="3597500"/>
            <a:ext cx="7998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4616869" y="3374171"/>
            <a:ext cx="665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    TF-3</a:t>
            </a:r>
            <a:endParaRPr lang="en-US" sz="1200" dirty="0"/>
          </a:p>
        </p:txBody>
      </p:sp>
      <p:sp>
        <p:nvSpPr>
          <p:cNvPr id="98" name="Rectangle 97"/>
          <p:cNvSpPr/>
          <p:nvPr/>
        </p:nvSpPr>
        <p:spPr>
          <a:xfrm>
            <a:off x="266699" y="6027003"/>
            <a:ext cx="865234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2 and TMPRSS2 expression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 protein level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549 cells treated with indicate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henol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different concentration for 48h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was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n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Western blot method with mouse anti-ACE2monoclonal antibody, anti-TMPRSS2 monoclonal antibody, and anti-β-act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load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. 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µg/well of protein was separated on 8-16% gradient SDS-PAG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ted original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s were acquired using the Azu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eri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gital system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o-exposure settings.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609601" y="1447800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609601" y="1867676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-103417" y="1287621"/>
            <a:ext cx="8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0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64" name="TextBox 63"/>
          <p:cNvSpPr txBox="1"/>
          <p:nvPr/>
        </p:nvSpPr>
        <p:spPr>
          <a:xfrm>
            <a:off x="-47043" y="1716828"/>
            <a:ext cx="8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cxnSp>
        <p:nvCxnSpPr>
          <p:cNvPr id="67" name="Straight Connector 66"/>
          <p:cNvCxnSpPr/>
          <p:nvPr/>
        </p:nvCxnSpPr>
        <p:spPr>
          <a:xfrm>
            <a:off x="5355690" y="1122786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5355690" y="1369285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4642672" y="990600"/>
            <a:ext cx="8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0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74" name="TextBox 73"/>
          <p:cNvSpPr txBox="1"/>
          <p:nvPr/>
        </p:nvSpPr>
        <p:spPr>
          <a:xfrm>
            <a:off x="4699046" y="1246430"/>
            <a:ext cx="8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cxnSp>
        <p:nvCxnSpPr>
          <p:cNvPr id="79" name="Straight Connector 78"/>
          <p:cNvCxnSpPr/>
          <p:nvPr/>
        </p:nvCxnSpPr>
        <p:spPr>
          <a:xfrm>
            <a:off x="5340264" y="1780785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2654506" y="4738177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4627246" y="1648598"/>
            <a:ext cx="856083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82" name="TextBox 81"/>
          <p:cNvSpPr txBox="1"/>
          <p:nvPr/>
        </p:nvSpPr>
        <p:spPr>
          <a:xfrm>
            <a:off x="1997862" y="4587329"/>
            <a:ext cx="8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240117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329781" y="-328127"/>
            <a:ext cx="2865437" cy="3886200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404618" y="2645033"/>
            <a:ext cx="2715757" cy="3886200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242584" y="1276213"/>
            <a:ext cx="1790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ro-</a:t>
            </a:r>
            <a:r>
              <a:rPr lang="en-US" dirty="0" err="1" smtClean="0"/>
              <a:t>cathepsinL</a:t>
            </a:r>
            <a:endParaRPr lang="en-US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2804682" y="1508589"/>
            <a:ext cx="228601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975911" y="4200695"/>
            <a:ext cx="1066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actin</a:t>
            </a:r>
            <a:endParaRPr lang="en-US" dirty="0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2814109" y="4384030"/>
            <a:ext cx="228601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259188" y="1513866"/>
            <a:ext cx="1790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</a:t>
            </a:r>
            <a:r>
              <a:rPr lang="en-US" dirty="0" smtClean="0"/>
              <a:t>      </a:t>
            </a:r>
            <a:r>
              <a:rPr lang="en-US" dirty="0" err="1" smtClean="0"/>
              <a:t>cathepsinL</a:t>
            </a:r>
            <a:endParaRPr lang="en-US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2821286" y="1660989"/>
            <a:ext cx="228601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 rot="18724095">
            <a:off x="3162254" y="3627815"/>
            <a:ext cx="7424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Control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 rot="18724095">
            <a:off x="3426508" y="3481200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 rot="18724095">
            <a:off x="3755346" y="3486382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 rot="18724095">
            <a:off x="4053825" y="346900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 rot="18724095">
            <a:off x="4361396" y="348548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 rot="18724095">
            <a:off x="4665182" y="3508348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 rot="18724095">
            <a:off x="4976187" y="3503498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 rot="18724095">
            <a:off x="5262226" y="3498527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 rot="18724095">
            <a:off x="5591064" y="3503710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 rot="18724095">
            <a:off x="5910448" y="3498860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5841198" y="3453310"/>
            <a:ext cx="702058" cy="395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5802606" y="3227893"/>
            <a:ext cx="816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urcumin</a:t>
            </a:r>
            <a:endParaRPr lang="en-US" sz="1200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3926483" y="3453310"/>
            <a:ext cx="74869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3911243" y="3229981"/>
            <a:ext cx="763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Brazilin</a:t>
            </a:r>
            <a:endParaRPr lang="en-US" sz="1200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4847772" y="3457264"/>
            <a:ext cx="7998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4782428" y="3233935"/>
            <a:ext cx="665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    TF-3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 rot="18724095">
            <a:off x="3142768" y="532633"/>
            <a:ext cx="7424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Control</a:t>
            </a:r>
            <a:endParaRPr lang="en-US" sz="1000" dirty="0"/>
          </a:p>
        </p:txBody>
      </p:sp>
      <p:sp>
        <p:nvSpPr>
          <p:cNvPr id="41" name="TextBox 40"/>
          <p:cNvSpPr txBox="1"/>
          <p:nvPr/>
        </p:nvSpPr>
        <p:spPr>
          <a:xfrm rot="18724095">
            <a:off x="3407022" y="386018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 rot="18724095">
            <a:off x="3735860" y="391200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 rot="18724095">
            <a:off x="4034339" y="37382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 rot="18724095">
            <a:off x="4341910" y="390304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 rot="18724095">
            <a:off x="4645696" y="41316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 rot="18724095">
            <a:off x="4956701" y="408316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 rot="18724095">
            <a:off x="5242740" y="403345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5.0 µg/ml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 rot="18724095">
            <a:off x="5571578" y="408528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0 µg/ml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 rot="18724095">
            <a:off x="5890962" y="403678"/>
            <a:ext cx="1116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25 µg/ml</a:t>
            </a:r>
            <a:endParaRPr lang="en-US" sz="1000" dirty="0"/>
          </a:p>
        </p:txBody>
      </p:sp>
      <p:cxnSp>
        <p:nvCxnSpPr>
          <p:cNvPr id="50" name="Straight Connector 49"/>
          <p:cNvCxnSpPr/>
          <p:nvPr/>
        </p:nvCxnSpPr>
        <p:spPr>
          <a:xfrm>
            <a:off x="5821712" y="358128"/>
            <a:ext cx="702058" cy="395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5783120" y="132711"/>
            <a:ext cx="816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urcumin</a:t>
            </a:r>
            <a:endParaRPr lang="en-US" sz="1200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3906997" y="358128"/>
            <a:ext cx="74869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3891757" y="134799"/>
            <a:ext cx="763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Brazilin</a:t>
            </a:r>
            <a:endParaRPr lang="en-US" sz="1200" dirty="0"/>
          </a:p>
        </p:txBody>
      </p:sp>
      <p:cxnSp>
        <p:nvCxnSpPr>
          <p:cNvPr id="54" name="Straight Connector 53"/>
          <p:cNvCxnSpPr/>
          <p:nvPr/>
        </p:nvCxnSpPr>
        <p:spPr>
          <a:xfrm>
            <a:off x="4828286" y="362082"/>
            <a:ext cx="7998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4762942" y="138753"/>
            <a:ext cx="665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    TF-3</a:t>
            </a:r>
            <a:endParaRPr lang="en-US" sz="1200" dirty="0"/>
          </a:p>
        </p:txBody>
      </p:sp>
      <p:sp>
        <p:nvSpPr>
          <p:cNvPr id="56" name="Rectangle 55"/>
          <p:cNvSpPr/>
          <p:nvPr/>
        </p:nvSpPr>
        <p:spPr>
          <a:xfrm>
            <a:off x="304800" y="6027003"/>
            <a:ext cx="859487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hepsin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 expression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 protein level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549 cells treated with indicate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henol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different concentration for 48h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was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n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Western blot method with mouse anti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hepsi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 monoclon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anti-β-act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load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. 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µg/well of protein was separated on 8-16% gradient SDS-PAG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ted original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s were acquired using the Azu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eri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gital system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o-exposure settings.</a:t>
            </a:r>
          </a:p>
        </p:txBody>
      </p:sp>
      <p:cxnSp>
        <p:nvCxnSpPr>
          <p:cNvPr id="59" name="Straight Connector 58"/>
          <p:cNvCxnSpPr/>
          <p:nvPr/>
        </p:nvCxnSpPr>
        <p:spPr>
          <a:xfrm>
            <a:off x="3049888" y="1354637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3049888" y="1905000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2336870" y="1194458"/>
            <a:ext cx="8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2393244" y="1780401"/>
            <a:ext cx="8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cxnSp>
        <p:nvCxnSpPr>
          <p:cNvPr id="63" name="Straight Arrow Connector 62"/>
          <p:cNvCxnSpPr/>
          <p:nvPr/>
        </p:nvCxnSpPr>
        <p:spPr>
          <a:xfrm>
            <a:off x="2815776" y="4384030"/>
            <a:ext cx="228601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2803283" y="4213043"/>
            <a:ext cx="2285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2146639" y="4062195"/>
            <a:ext cx="8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5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429100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</TotalTime>
  <Words>295</Words>
  <Application>Microsoft Office PowerPoint</Application>
  <PresentationFormat>On-screen Show (4:3)</PresentationFormat>
  <Paragraphs>8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Goc</dc:creator>
  <cp:lastModifiedBy>Anna Goc</cp:lastModifiedBy>
  <cp:revision>18</cp:revision>
  <dcterms:created xsi:type="dcterms:W3CDTF">2021-04-13T17:31:07Z</dcterms:created>
  <dcterms:modified xsi:type="dcterms:W3CDTF">2021-04-27T17:03:50Z</dcterms:modified>
</cp:coreProperties>
</file>